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82" r:id="rId3"/>
    <p:sldId id="30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1905A4-CD26-4243-8805-611FD8CEC439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3C0289-014C-4353-A2A9-352A7E50CAA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24889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685800" y="1143000"/>
            <a:ext cx="5486400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560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I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r" defTabSz="91281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3BD2EC00-5838-4F8E-A7BD-CA865211D64C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912813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7753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702D18-5A58-4387-A8CC-5272F5ADC2FD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918738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06344-4C0D-EBBE-490F-281015B041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15141E-ACE8-D607-C755-AE794D09BB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DB4B76-F69A-D7BD-5A74-8E0DC36E3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C3859A-5AAA-F850-3C4C-2494D83B0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634DF4-B128-960F-2E04-7BDC7D831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72018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4ADB0-8F0F-D892-A828-C0470F0363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3E34F3-E97B-B176-979B-45133FFD57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5F3D2E-1C55-006C-18BB-3DBD1F383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3425D-8BC2-A1E9-ABB6-DA97C03DD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EAF215-81B5-7442-6A07-05D302F00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974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FE732-C02F-D05D-E224-6A7A434B93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2F5A38-8D51-331C-BFDE-91A81DD285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C0F62-6A15-6A7B-E52C-1BE0DAA5E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F0A225-D91A-9478-6E44-A83E91CBE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303268-6F26-20E7-6F0C-0AC104810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36864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6B40F-806B-8952-74A1-905BF9D60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B6693B-55A2-FF98-B13F-B87598B734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D41BF5-81CF-0D84-EC18-F6DAD0585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9B1C90-E715-AA88-8FD8-63D1A3998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25F176-C838-251A-3088-061EF3B27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6752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D5AA5F-4F73-5CC6-CDF4-0838A96C8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594740-CAE9-0B3D-D3F2-21C416AA81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DF3100-3081-4D69-139D-D233BA605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C2B638-4537-A784-1A10-D9CB61795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F16992-39A0-25B0-3304-4E56382C4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193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35F4E-74D7-61B6-F5AA-76F2C046FD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448BE8-EE25-1DE0-D735-AF018EBCAD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60EE44-6364-BA74-FF09-816165D2C0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3BF59C-C06A-5270-0B1C-52BD6E9F5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CAB850-5ED1-D0B9-3100-0CD9AB368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B9155-4811-1C3B-284A-975958B06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6899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92D31-CF8A-D7D6-F0B7-7A22ECBD9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7240CE-8471-6C24-20EB-A4FD039E79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EF33F5-EB07-FCE1-9A7B-A4EF5F1485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46D11E-A922-5DEF-2572-EA8C6B62B7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4E9AAE8-B562-7D72-F98A-20DDBCCA2A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DB88B9-6A3F-B562-A01B-A60E3CCF1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F3B827-A574-B63E-9579-07BD4685C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A19895-C292-5463-8561-38E900E2F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7996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5BA05-FCDD-E50B-E16E-9F1EB0104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6F3ED3-B097-83E4-236A-B99AA931D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30D66F-9388-7C70-8265-920E6B760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0872F4-ABF9-8D2B-9713-84FA09F00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4976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367A8C-FB4F-EC09-BE66-0D99DB527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92B096-3620-6E2F-EE8E-20CF3D8ED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8B9903-53D3-E009-A1C4-3426B1529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4963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6AAA9-94D6-E417-9567-69A9FBFE2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074893-3BF6-C6C4-B2F0-5A3C0818AC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75F6A1-BF8F-4058-4977-2CF92367EA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E56848-E1A5-88FA-DB2A-8376530DE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7C6C72-07F7-41CC-DC25-6A092B326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CC01F3-1554-246A-C0E5-27E50C3C0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2444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4E0BA-3735-1C72-14B1-E1F88BB6D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BD5A88-CF40-BE80-C9CA-60C2B5E0D4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8268A1-079C-FFB2-543A-206863EA5D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29A0E3-5136-869C-54EC-4F854389E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C85B09-D83D-8F25-5620-7511E032E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4969D5-B4DD-52B9-99E2-1F84A61B5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129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34A207-9E3D-8D5F-ECDF-DF4D2D1DB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A28ADF-099E-2E4F-7101-8AD0F3A924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EE052A-6B68-8615-A822-4CBE11E5E7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E6BD7-BE4F-4A9F-907F-FC1082C64C5C}" type="datetimeFigureOut">
              <a:rPr lang="en-IN" smtClean="0"/>
              <a:t>24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128C08-3721-4232-123E-55E2692CD3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D8539B-64A4-163C-7E91-6EC74FE0A8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4E6BD-C43B-4829-B19E-8AEE89C414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9205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088DEA75-FEF3-6E37-8B29-66108525A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IN" dirty="0"/>
              <a:t>Supplementary Figures</a:t>
            </a:r>
            <a:br>
              <a:rPr lang="en-IN" dirty="0"/>
            </a:b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072875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70" name="Group 28"/>
          <p:cNvGrpSpPr>
            <a:grpSpLocks/>
          </p:cNvGrpSpPr>
          <p:nvPr/>
        </p:nvGrpSpPr>
        <p:grpSpPr bwMode="auto">
          <a:xfrm>
            <a:off x="1086397" y="386965"/>
            <a:ext cx="10079907" cy="5769580"/>
            <a:chOff x="54812" y="396664"/>
            <a:chExt cx="9020840" cy="6255870"/>
          </a:xfrm>
          <a:noFill/>
        </p:grpSpPr>
        <p:grpSp>
          <p:nvGrpSpPr>
            <p:cNvPr id="7171" name="Group 5151"/>
            <p:cNvGrpSpPr>
              <a:grpSpLocks/>
            </p:cNvGrpSpPr>
            <p:nvPr/>
          </p:nvGrpSpPr>
          <p:grpSpPr bwMode="auto">
            <a:xfrm>
              <a:off x="54812" y="396664"/>
              <a:ext cx="9020840" cy="6255870"/>
              <a:chOff x="152401" y="663785"/>
              <a:chExt cx="9020840" cy="6255870"/>
            </a:xfrm>
            <a:grpFill/>
          </p:grpSpPr>
          <p:grpSp>
            <p:nvGrpSpPr>
              <p:cNvPr id="7175" name="Group 5158"/>
              <p:cNvGrpSpPr>
                <a:grpSpLocks/>
              </p:cNvGrpSpPr>
              <p:nvPr/>
            </p:nvGrpSpPr>
            <p:grpSpPr bwMode="auto">
              <a:xfrm>
                <a:off x="152401" y="663785"/>
                <a:ext cx="9020840" cy="6255870"/>
                <a:chOff x="152401" y="663785"/>
                <a:chExt cx="9020840" cy="6255870"/>
              </a:xfrm>
              <a:grpFill/>
            </p:grpSpPr>
            <p:grpSp>
              <p:nvGrpSpPr>
                <p:cNvPr id="7177" name="Group 62"/>
                <p:cNvGrpSpPr>
                  <a:grpSpLocks/>
                </p:cNvGrpSpPr>
                <p:nvPr/>
              </p:nvGrpSpPr>
              <p:grpSpPr bwMode="auto">
                <a:xfrm>
                  <a:off x="152401" y="663785"/>
                  <a:ext cx="9020840" cy="6122650"/>
                  <a:chOff x="152400" y="477895"/>
                  <a:chExt cx="9020840" cy="5612322"/>
                </a:xfrm>
                <a:grpFill/>
              </p:grpSpPr>
              <p:grpSp>
                <p:nvGrpSpPr>
                  <p:cNvPr id="7183" name="Group 100"/>
                  <p:cNvGrpSpPr>
                    <a:grpSpLocks/>
                  </p:cNvGrpSpPr>
                  <p:nvPr/>
                </p:nvGrpSpPr>
                <p:grpSpPr bwMode="auto">
                  <a:xfrm>
                    <a:off x="169242" y="477895"/>
                    <a:ext cx="9003998" cy="5612322"/>
                    <a:chOff x="169242" y="477895"/>
                    <a:chExt cx="9003998" cy="5612322"/>
                  </a:xfrm>
                  <a:grpFill/>
                </p:grpSpPr>
                <p:sp>
                  <p:nvSpPr>
                    <p:cNvPr id="7187" name="TextBox 2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273655" y="477895"/>
                      <a:ext cx="2743200" cy="265474"/>
                    </a:xfrm>
                    <a:prstGeom prst="rect">
                      <a:avLst/>
                    </a:prstGeom>
                    <a:grpFill/>
                    <a:ln>
                      <a:noFill/>
                      <a:headEnd/>
                      <a:tailEnd/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lIns="81639" tIns="40819" rIns="81639" bIns="40819">
                      <a:spAutoFit/>
                    </a:bodyPr>
                    <a:lstStyle>
                      <a:lvl1pPr eaLnBrk="0" hangingPunct="0"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1pPr>
                      <a:lvl2pPr marL="742950" indent="-285750" eaLnBrk="0" hangingPunct="0"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2pPr>
                      <a:lvl3pPr marL="1143000" indent="-228600" eaLnBrk="0" hangingPunct="0"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3pPr>
                      <a:lvl4pPr marL="1600200" indent="-228600" eaLnBrk="0" hangingPunct="0"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4pPr>
                      <a:lvl5pPr marL="2057400" indent="-228600" eaLnBrk="0" hangingPunct="0"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5pPr>
                      <a:lvl6pPr marL="2514600" indent="-228600" defTabSz="912813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6pPr>
                      <a:lvl7pPr marL="2971800" indent="-228600" defTabSz="912813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7pPr>
                      <a:lvl8pPr marL="3429000" indent="-228600" defTabSz="912813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8pPr>
                      <a:lvl9pPr marL="3886200" indent="-228600" defTabSz="912813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lvl9pPr>
                    </a:lstStyle>
                    <a:p>
                      <a:pPr algn="ctr" defTabSz="912813" eaLnBrk="1" fontAlgn="base" hangingPunct="1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en-US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outline</a:t>
                      </a:r>
                    </a:p>
                  </p:txBody>
                </p:sp>
                <p:grpSp>
                  <p:nvGrpSpPr>
                    <p:cNvPr id="7188" name="Group 60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9242" y="762030"/>
                      <a:ext cx="9003998" cy="5318002"/>
                      <a:chOff x="192293" y="762021"/>
                      <a:chExt cx="8434062" cy="3723514"/>
                    </a:xfrm>
                    <a:grpFill/>
                  </p:grpSpPr>
                  <p:grpSp>
                    <p:nvGrpSpPr>
                      <p:cNvPr id="7194" name="Group 79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192293" y="762021"/>
                        <a:ext cx="8434062" cy="3723514"/>
                        <a:chOff x="343701" y="762021"/>
                        <a:chExt cx="8361972" cy="3723514"/>
                      </a:xfrm>
                      <a:grpFill/>
                    </p:grpSpPr>
                    <p:grpSp>
                      <p:nvGrpSpPr>
                        <p:cNvPr id="7198" name="Group 69"/>
                        <p:cNvGrpSpPr>
                          <a:grpSpLocks/>
                        </p:cNvGrpSpPr>
                        <p:nvPr/>
                      </p:nvGrpSpPr>
                      <p:grpSpPr bwMode="auto">
                        <a:xfrm>
                          <a:off x="343701" y="762021"/>
                          <a:ext cx="8361972" cy="3544994"/>
                          <a:chOff x="343701" y="762021"/>
                          <a:chExt cx="8361972" cy="3544994"/>
                        </a:xfrm>
                        <a:grpFill/>
                      </p:grpSpPr>
                      <p:sp>
                        <p:nvSpPr>
                          <p:cNvPr id="66" name="TextBox 65"/>
                          <p:cNvSpPr txBox="1"/>
                          <p:nvPr/>
                        </p:nvSpPr>
                        <p:spPr>
                          <a:xfrm>
                            <a:off x="6696048" y="2526489"/>
                            <a:ext cx="1220814" cy="192766"/>
                          </a:xfrm>
                          <a:prstGeom prst="rect">
                            <a:avLst/>
                          </a:prstGeom>
                          <a:grpFill/>
                          <a:ln/>
                        </p:spPr>
                        <p:style>
                          <a:lnRef idx="2">
                            <a:schemeClr val="dk1"/>
                          </a:lnRef>
                          <a:fillRef idx="1">
                            <a:schemeClr val="lt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>
                            <a:spAutoFit/>
                          </a:bodyPr>
                          <a:lstStyle/>
                          <a:p>
                            <a:pPr marL="0" lvl="1" indent="1588" algn="ctr" defTabSz="912813" fontAlgn="base">
                              <a:spcBef>
                                <a:spcPct val="0"/>
                              </a:spcBef>
                              <a:spcAft>
                                <a:spcPct val="0"/>
                              </a:spcAft>
                              <a:defRPr/>
                            </a:pPr>
                            <a:r>
                              <a:rPr lang="en-US" sz="1200" b="1" dirty="0">
                                <a:solidFill>
                                  <a:prstClr val="black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PBMCs</a:t>
                            </a:r>
                          </a:p>
                        </p:txBody>
                      </p:sp>
                      <p:grpSp>
                        <p:nvGrpSpPr>
                          <p:cNvPr id="7201" name="Group 68"/>
                          <p:cNvGrpSpPr>
                            <a:grpSpLocks/>
                          </p:cNvGrpSpPr>
                          <p:nvPr/>
                        </p:nvGrpSpPr>
                        <p:grpSpPr bwMode="auto">
                          <a:xfrm>
                            <a:off x="343701" y="762021"/>
                            <a:ext cx="8361972" cy="3544994"/>
                            <a:chOff x="343701" y="762021"/>
                            <a:chExt cx="8361972" cy="3544994"/>
                          </a:xfrm>
                          <a:grpFill/>
                        </p:grpSpPr>
                        <p:grpSp>
                          <p:nvGrpSpPr>
                            <p:cNvPr id="7202" name="Group 64"/>
                            <p:cNvGrpSpPr>
                              <a:grpSpLocks/>
                            </p:cNvGrpSpPr>
                            <p:nvPr/>
                          </p:nvGrpSpPr>
                          <p:grpSpPr bwMode="auto">
                            <a:xfrm>
                              <a:off x="343701" y="762021"/>
                              <a:ext cx="8361972" cy="3544994"/>
                              <a:chOff x="343701" y="762021"/>
                              <a:chExt cx="8361972" cy="3544994"/>
                            </a:xfrm>
                            <a:grpFill/>
                          </p:grpSpPr>
                          <p:grpSp>
                            <p:nvGrpSpPr>
                              <p:cNvPr id="7204" name="Group 60"/>
                              <p:cNvGrpSpPr>
                                <a:grpSpLocks/>
                              </p:cNvGrpSpPr>
                              <p:nvPr/>
                            </p:nvGrpSpPr>
                            <p:grpSpPr bwMode="auto">
                              <a:xfrm>
                                <a:off x="343701" y="762021"/>
                                <a:ext cx="8361972" cy="3544994"/>
                                <a:chOff x="343701" y="762021"/>
                                <a:chExt cx="8361972" cy="3544994"/>
                              </a:xfrm>
                              <a:grpFill/>
                            </p:grpSpPr>
                            <p:grpSp>
                              <p:nvGrpSpPr>
                                <p:cNvPr id="7206" name="Group 58"/>
                                <p:cNvGrpSpPr>
                                  <a:grpSpLocks/>
                                </p:cNvGrpSpPr>
                                <p:nvPr/>
                              </p:nvGrpSpPr>
                              <p:grpSpPr bwMode="auto">
                                <a:xfrm>
                                  <a:off x="343701" y="762021"/>
                                  <a:ext cx="8361972" cy="3544994"/>
                                  <a:chOff x="343701" y="762021"/>
                                  <a:chExt cx="8361972" cy="3544994"/>
                                </a:xfrm>
                                <a:grpFill/>
                              </p:grpSpPr>
                              <p:grpSp>
                                <p:nvGrpSpPr>
                                  <p:cNvPr id="7208" name="Group 55"/>
                                  <p:cNvGrpSpPr>
                                    <a:grpSpLocks/>
                                  </p:cNvGrpSpPr>
                                  <p:nvPr/>
                                </p:nvGrpSpPr>
                                <p:grpSpPr bwMode="auto">
                                  <a:xfrm>
                                    <a:off x="343701" y="762021"/>
                                    <a:ext cx="8361972" cy="3544994"/>
                                    <a:chOff x="343701" y="762021"/>
                                    <a:chExt cx="8361972" cy="3544994"/>
                                  </a:xfrm>
                                  <a:grpFill/>
                                </p:grpSpPr>
                                <p:grpSp>
                                  <p:nvGrpSpPr>
                                    <p:cNvPr id="7210" name="Group 43"/>
                                    <p:cNvGrpSpPr>
                                      <a:grpSpLocks/>
                                    </p:cNvGrpSpPr>
                                    <p:nvPr/>
                                  </p:nvGrpSpPr>
                                  <p:grpSpPr bwMode="auto">
                                    <a:xfrm>
                                      <a:off x="343701" y="762021"/>
                                      <a:ext cx="8361972" cy="3544994"/>
                                      <a:chOff x="343701" y="762021"/>
                                      <a:chExt cx="8361972" cy="3544994"/>
                                    </a:xfrm>
                                    <a:grpFill/>
                                  </p:grpSpPr>
                                  <p:grpSp>
                                    <p:nvGrpSpPr>
                                      <p:cNvPr id="7212" name="Group 35"/>
                                      <p:cNvGrpSpPr>
                                        <a:grpSpLocks/>
                                      </p:cNvGrpSpPr>
                                      <p:nvPr/>
                                    </p:nvGrpSpPr>
                                    <p:grpSpPr bwMode="auto">
                                      <a:xfrm>
                                        <a:off x="343701" y="762021"/>
                                        <a:ext cx="8361972" cy="3544994"/>
                                        <a:chOff x="267501" y="1143021"/>
                                        <a:chExt cx="8361972" cy="3544994"/>
                                      </a:xfrm>
                                      <a:grpFill/>
                                    </p:grpSpPr>
                                    <p:grpSp>
                                      <p:nvGrpSpPr>
                                        <p:cNvPr id="7215" name="Group 16"/>
                                        <p:cNvGrpSpPr>
                                          <a:grpSpLocks/>
                                        </p:cNvGrpSpPr>
                                        <p:nvPr/>
                                      </p:nvGrpSpPr>
                                      <p:grpSpPr bwMode="auto">
                                        <a:xfrm>
                                          <a:off x="1121763" y="1143021"/>
                                          <a:ext cx="6506215" cy="484923"/>
                                          <a:chOff x="1121763" y="533421"/>
                                          <a:chExt cx="6506215" cy="484923"/>
                                        </a:xfrm>
                                        <a:grpFill/>
                                      </p:grpSpPr>
                                      <p:grpSp>
                                        <p:nvGrpSpPr>
                                          <p:cNvPr id="7223" name="Group 13"/>
                                          <p:cNvGrpSpPr>
                                            <a:grpSpLocks/>
                                          </p:cNvGrpSpPr>
                                          <p:nvPr/>
                                        </p:nvGrpSpPr>
                                        <p:grpSpPr bwMode="auto">
                                          <a:xfrm>
                                            <a:off x="1121763" y="533421"/>
                                            <a:ext cx="6506215" cy="475754"/>
                                            <a:chOff x="1121763" y="533421"/>
                                            <a:chExt cx="6506215" cy="475754"/>
                                          </a:xfrm>
                                          <a:grpFill/>
                                        </p:grpSpPr>
                                        <p:grpSp>
                                          <p:nvGrpSpPr>
                                            <p:cNvPr id="7225" name="Group 10"/>
                                            <p:cNvGrpSpPr>
                                              <a:grpSpLocks/>
                                            </p:cNvGrpSpPr>
                                            <p:nvPr/>
                                          </p:nvGrpSpPr>
                                          <p:grpSpPr bwMode="auto">
                                            <a:xfrm>
                                              <a:off x="1133190" y="533421"/>
                                              <a:ext cx="6494788" cy="304605"/>
                                              <a:chOff x="1133190" y="533421"/>
                                              <a:chExt cx="6494788" cy="304605"/>
                                            </a:xfrm>
                                            <a:grpFill/>
                                          </p:grpSpPr>
                                          <p:cxnSp>
                                            <p:nvCxnSpPr>
                                              <p:cNvPr id="7" name="Straight Connector 6"/>
                                              <p:cNvCxnSpPr/>
                                              <p:nvPr/>
                                            </p:nvCxnSpPr>
                                            <p:spPr>
                                              <a:xfrm rot="5400000">
                                                <a:off x="4190315" y="684987"/>
                                                <a:ext cx="304605" cy="1474"/>
                                              </a:xfrm>
                                              <a:prstGeom prst="line">
                                                <a:avLst/>
                                              </a:prstGeom>
                                              <a:grpFill/>
                                              <a:ln w="12700"/>
                                            </p:spPr>
                                            <p:style>
                                              <a:lnRef idx="1">
                                                <a:schemeClr val="dk1"/>
                                              </a:lnRef>
                                              <a:fillRef idx="0">
                                                <a:schemeClr val="dk1"/>
                                              </a:fillRef>
                                              <a:effectRef idx="0">
                                                <a:schemeClr val="dk1"/>
                                              </a:effectRef>
                                              <a:fontRef idx="minor">
                                                <a:schemeClr val="tx1"/>
                                              </a:fontRef>
                                            </p:style>
                                          </p:cxnSp>
                                          <p:cxnSp>
                                            <p:nvCxnSpPr>
                                              <p:cNvPr id="9" name="Straight Connector 8"/>
                                              <p:cNvCxnSpPr/>
                                              <p:nvPr/>
                                            </p:nvCxnSpPr>
                                            <p:spPr>
                                              <a:xfrm>
                                                <a:off x="1133190" y="699802"/>
                                                <a:ext cx="6494788" cy="19356"/>
                                              </a:xfrm>
                                              <a:prstGeom prst="line">
                                                <a:avLst/>
                                              </a:prstGeom>
                                              <a:grpFill/>
                                              <a:ln w="12700"/>
                                            </p:spPr>
                                            <p:style>
                                              <a:lnRef idx="1">
                                                <a:schemeClr val="dk1"/>
                                              </a:lnRef>
                                              <a:fillRef idx="0">
                                                <a:schemeClr val="dk1"/>
                                              </a:fillRef>
                                              <a:effectRef idx="0">
                                                <a:schemeClr val="dk1"/>
                                              </a:effectRef>
                                              <a:fontRef idx="minor">
                                                <a:schemeClr val="tx1"/>
                                              </a:fontRef>
                                            </p:style>
                                          </p:cxnSp>
                                        </p:grpSp>
                                        <p:cxnSp>
                                          <p:nvCxnSpPr>
                                            <p:cNvPr id="13" name="Straight Arrow Connector 12"/>
                                            <p:cNvCxnSpPr/>
                                            <p:nvPr/>
                                          </p:nvCxnSpPr>
                                          <p:spPr>
                                            <a:xfrm rot="5400000">
                                              <a:off x="970198" y="856136"/>
                                              <a:ext cx="304604" cy="1474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grpFill/>
                                            <a:ln w="12700">
                                              <a:tailEnd type="arrow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dk1"/>
                                            </a:lnRef>
                                            <a:fillRef idx="0">
                                              <a:schemeClr val="dk1"/>
                                            </a:fillRef>
                                            <a:effectRef idx="0">
                                              <a:schemeClr val="dk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</p:grpSp>
                                      <p:cxnSp>
                                        <p:nvCxnSpPr>
                                          <p:cNvPr id="16" name="Straight Arrow Connector 15"/>
                                          <p:cNvCxnSpPr/>
                                          <p:nvPr/>
                                        </p:nvCxnSpPr>
                                        <p:spPr>
                                          <a:xfrm rot="5400000">
                                            <a:off x="7466460" y="865305"/>
                                            <a:ext cx="304605" cy="1474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grpFill/>
                                          <a:ln w="12700">
                                            <a:tailEnd type="arrow"/>
                                          </a:ln>
                                        </p:spPr>
                                        <p:style>
                                          <a:lnRef idx="1">
                                            <a:schemeClr val="dk1"/>
                                          </a:lnRef>
                                          <a:fillRef idx="0">
                                            <a:schemeClr val="dk1"/>
                                          </a:fillRef>
                                          <a:effectRef idx="0">
                                            <a:schemeClr val="dk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</p:grpSp>
                                    <p:sp>
                                      <p:nvSpPr>
                                        <p:cNvPr id="7216" name="TextBox 17"/>
                                        <p:cNvSpPr txBox="1">
                                          <a:spLocks noChangeArrowheads="1"/>
                                        </p:cNvSpPr>
                                        <p:nvPr/>
                                      </p:nvSpPr>
                                      <p:spPr bwMode="auto">
                                        <a:xfrm>
                                          <a:off x="267501" y="1647450"/>
                                          <a:ext cx="2104563" cy="578297"/>
                                        </a:xfrm>
                                        <a:prstGeom prst="rect">
                                          <a:avLst/>
                                        </a:prstGeom>
                                        <a:grpFill/>
                                        <a:ln/>
                                      </p:spPr>
                                      <p:style>
                                        <a:lnRef idx="2">
                                          <a:schemeClr val="dk1"/>
                                        </a:lnRef>
                                        <a:fillRef idx="1">
                                          <a:schemeClr val="lt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dk1"/>
                                        </a:fontRef>
                                      </p:style>
                                      <p:txBody>
                                        <a:bodyPr wrap="square">
                                          <a:spAutoFit/>
                                        </a:bodyPr>
                                        <a:lstStyle>
                                          <a:lvl1pPr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1pPr>
                                          <a:lvl2pPr marL="742950" indent="-28575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2pPr>
                                          <a:lvl3pPr marL="11430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3pPr>
                                          <a:lvl4pPr marL="16002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4pPr>
                                          <a:lvl5pPr marL="20574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5pPr>
                                          <a:lvl6pPr marL="25146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6pPr>
                                          <a:lvl7pPr marL="29718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7pPr>
                                          <a:lvl8pPr marL="34290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8pPr>
                                          <a:lvl9pPr marL="38862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9pPr>
                                        </a:lstStyle>
                                        <a:p>
                                          <a:pPr algn="ctr" defTabSz="912813" eaLnBrk="1" fontAlgn="base" hangingPunct="1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</a:pPr>
                                          <a:r>
                                            <a:rPr lang="en-IN" alt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R1 </a:t>
                                          </a:r>
                                        </a:p>
                                        <a:p>
                                          <a:pPr algn="ctr" defTabSz="912813" eaLnBrk="1" fontAlgn="base" hangingPunct="1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</a:pPr>
                                          <a:r>
                                            <a:rPr lang="en-IN" alt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(Recovered 1-2 months post recovery, </a:t>
                                          </a:r>
                                        </a:p>
                                        <a:p>
                                          <a:pPr algn="ctr" defTabSz="912813" eaLnBrk="1" fontAlgn="base" hangingPunct="1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</a:pPr>
                                          <a:r>
                                            <a:rPr lang="en-US" alt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n=40</a:t>
                                          </a:r>
                                          <a:r>
                                            <a:rPr lang="en-US" altLang="en-US" sz="1200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)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5158" name="TextBox 28"/>
                                        <p:cNvSpPr txBox="1">
                                          <a:spLocks noChangeArrowheads="1"/>
                                        </p:cNvSpPr>
                                        <p:nvPr/>
                                      </p:nvSpPr>
                                      <p:spPr bwMode="auto">
                                        <a:xfrm>
                                          <a:off x="6930348" y="1645564"/>
                                          <a:ext cx="1456159" cy="578297"/>
                                        </a:xfrm>
                                        <a:prstGeom prst="rect">
                                          <a:avLst/>
                                        </a:prstGeom>
                                        <a:grpFill/>
                                        <a:ln>
                                          <a:headEnd/>
                                          <a:tailEnd/>
                                        </a:ln>
                                      </p:spPr>
                                      <p:style>
                                        <a:lnRef idx="2">
                                          <a:schemeClr val="dk1"/>
                                        </a:lnRef>
                                        <a:fillRef idx="1">
                                          <a:schemeClr val="lt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dk1"/>
                                        </a:fontRef>
                                      </p:style>
                                      <p:txBody>
                                        <a:bodyPr wrap="square">
                                          <a:spAutoFit/>
                                        </a:bodyPr>
                                        <a:lstStyle/>
                                        <a:p>
                                          <a:pPr algn="ctr" defTabSz="912813" fontAlgn="base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/>
                                          </a:pPr>
                                          <a:r>
                                            <a:rPr 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HC</a:t>
                                          </a:r>
                                        </a:p>
                                        <a:p>
                                          <a:pPr algn="ctr" defTabSz="912813" fontAlgn="base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/>
                                          </a:pPr>
                                          <a:r>
                                            <a:rPr 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(Uninfected/</a:t>
                                          </a:r>
                                        </a:p>
                                        <a:p>
                                          <a:pPr algn="ctr" defTabSz="912813" fontAlgn="base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/>
                                          </a:pPr>
                                          <a:r>
                                            <a:rPr 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Healthy controls,</a:t>
                                          </a:r>
                                        </a:p>
                                        <a:p>
                                          <a:pPr algn="ctr" defTabSz="912813" fontAlgn="base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/>
                                          </a:pPr>
                                          <a:r>
                                            <a:rPr 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 n=56)</a:t>
                                          </a:r>
                                        </a:p>
                                      </p:txBody>
                                    </p:sp>
                                    <p:cxnSp>
                                      <p:nvCxnSpPr>
                                        <p:cNvPr id="33" name="Straight Connector 32"/>
                                        <p:cNvCxnSpPr>
                                          <a:endCxn id="66" idx="1"/>
                                        </p:cNvCxnSpPr>
                                        <p:nvPr/>
                                      </p:nvCxnSpPr>
                                      <p:spPr>
                                        <a:xfrm flipV="1">
                                          <a:off x="2952984" y="3003872"/>
                                          <a:ext cx="3666864" cy="51334"/>
                                        </a:xfrm>
                                        <a:prstGeom prst="line">
                                          <a:avLst/>
                                        </a:prstGeom>
                                        <a:grpFill/>
                                        <a:ln w="12700"/>
                                      </p:spPr>
                                      <p:style>
                                        <a:lnRef idx="1">
                                          <a:schemeClr val="dk1"/>
                                        </a:lnRef>
                                        <a:fillRef idx="0">
                                          <a:schemeClr val="dk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sp>
                                      <p:nvSpPr>
                                        <p:cNvPr id="7219" name="TextBox 37"/>
                                        <p:cNvSpPr txBox="1">
                                          <a:spLocks noChangeArrowheads="1"/>
                                        </p:cNvSpPr>
                                        <p:nvPr/>
                                      </p:nvSpPr>
                                      <p:spPr bwMode="auto">
                                        <a:xfrm>
                                          <a:off x="3324710" y="4495249"/>
                                          <a:ext cx="5290372" cy="192766"/>
                                        </a:xfrm>
                                        <a:prstGeom prst="rect">
                                          <a:avLst/>
                                        </a:prstGeom>
                                        <a:grpFill/>
                                        <a:ln>
                                          <a:headEnd/>
                                          <a:tailEnd/>
                                        </a:ln>
                                      </p:spPr>
                                      <p:style>
                                        <a:lnRef idx="2">
                                          <a:schemeClr val="dk1"/>
                                        </a:lnRef>
                                        <a:fillRef idx="1">
                                          <a:schemeClr val="lt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dk1"/>
                                        </a:fontRef>
                                      </p:style>
                                      <p:txBody>
                                        <a:bodyPr>
                                          <a:spAutoFit/>
                                        </a:bodyPr>
                                        <a:lstStyle>
                                          <a:lvl1pPr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1pPr>
                                          <a:lvl2pPr marL="742950" indent="-28575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2pPr>
                                          <a:lvl3pPr marL="11430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3pPr>
                                          <a:lvl4pPr marL="16002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4pPr>
                                          <a:lvl5pPr marL="20574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5pPr>
                                          <a:lvl6pPr marL="25146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6pPr>
                                          <a:lvl7pPr marL="29718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7pPr>
                                          <a:lvl8pPr marL="34290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8pPr>
                                          <a:lvl9pPr marL="38862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9pPr>
                                        </a:lstStyle>
                                        <a:p>
                                          <a:pPr defTabSz="912813" eaLnBrk="1" fontAlgn="base" hangingPunct="1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</a:pPr>
                                          <a:r>
                                            <a:rPr lang="en-US" alt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6.SARS CoV-2 S1 specific CTL response (T-cell ELISPOT) </a:t>
                                          </a:r>
                                          <a:r>
                                            <a:rPr lang="en-US" altLang="en-US" sz="1200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(n=117)</a:t>
                                          </a:r>
                                        </a:p>
                                      </p:txBody>
                                    </p:sp>
                                    <p:cxnSp>
                                      <p:nvCxnSpPr>
                                        <p:cNvPr id="40" name="Straight Connector 39"/>
                                        <p:cNvCxnSpPr/>
                                        <p:nvPr/>
                                      </p:nvCxnSpPr>
                                      <p:spPr>
                                        <a:xfrm rot="5400000">
                                          <a:off x="1446008" y="2289392"/>
                                          <a:ext cx="160962" cy="1474"/>
                                        </a:xfrm>
                                        <a:prstGeom prst="line">
                                          <a:avLst/>
                                        </a:prstGeom>
                                        <a:grpFill/>
                                        <a:ln w="12700"/>
                                      </p:spPr>
                                      <p:style>
                                        <a:lnRef idx="1">
                                          <a:schemeClr val="dk1"/>
                                        </a:lnRef>
                                        <a:fillRef idx="0">
                                          <a:schemeClr val="dk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41" name="Straight Connector 40"/>
                                        <p:cNvCxnSpPr/>
                                        <p:nvPr/>
                                      </p:nvCxnSpPr>
                                      <p:spPr>
                                        <a:xfrm>
                                          <a:off x="1596524" y="2583528"/>
                                          <a:ext cx="5848995" cy="15281"/>
                                        </a:xfrm>
                                        <a:prstGeom prst="line">
                                          <a:avLst/>
                                        </a:prstGeom>
                                        <a:grpFill/>
                                        <a:ln w="12700"/>
                                      </p:spPr>
                                      <p:style>
                                        <a:lnRef idx="1">
                                          <a:schemeClr val="dk1"/>
                                        </a:lnRef>
                                        <a:fillRef idx="0">
                                          <a:schemeClr val="dk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sp>
                                      <p:nvSpPr>
                                        <p:cNvPr id="7222" name="TextBox 49"/>
                                        <p:cNvSpPr txBox="1">
                                          <a:spLocks noChangeArrowheads="1"/>
                                        </p:cNvSpPr>
                                        <p:nvPr/>
                                      </p:nvSpPr>
                                      <p:spPr bwMode="auto">
                                        <a:xfrm>
                                          <a:off x="3324710" y="3226232"/>
                                          <a:ext cx="5304763" cy="321276"/>
                                        </a:xfrm>
                                        <a:prstGeom prst="rect">
                                          <a:avLst/>
                                        </a:prstGeom>
                                        <a:grpFill/>
                                        <a:ln>
                                          <a:headEnd/>
                                          <a:tailEnd/>
                                        </a:ln>
                                      </p:spPr>
                                      <p:style>
                                        <a:lnRef idx="2">
                                          <a:schemeClr val="dk1"/>
                                        </a:lnRef>
                                        <a:fillRef idx="1">
                                          <a:schemeClr val="lt1"/>
                                        </a:fillRef>
                                        <a:effectRef idx="0">
                                          <a:schemeClr val="dk1"/>
                                        </a:effectRef>
                                        <a:fontRef idx="minor">
                                          <a:schemeClr val="dk1"/>
                                        </a:fontRef>
                                      </p:style>
                                      <p:txBody>
                                        <a:bodyPr>
                                          <a:spAutoFit/>
                                        </a:bodyPr>
                                        <a:lstStyle>
                                          <a:lvl1pPr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1pPr>
                                          <a:lvl2pPr marL="742950" indent="-28575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2pPr>
                                          <a:lvl3pPr marL="11430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3pPr>
                                          <a:lvl4pPr marL="16002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4pPr>
                                          <a:lvl5pPr marL="2057400" indent="-228600" eaLnBrk="0" hangingPunct="0"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5pPr>
                                          <a:lvl6pPr marL="25146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6pPr>
                                          <a:lvl7pPr marL="29718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7pPr>
                                          <a:lvl8pPr marL="34290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8pPr>
                                          <a:lvl9pPr marL="3886200" indent="-228600" defTabSz="912813" eaLnBrk="0" fontAlgn="base" hangingPunct="0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  <a:defRPr>
                                              <a:solidFill>
                                                <a:schemeClr val="tx1"/>
                                              </a:solidFill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defRPr>
                                          </a:lvl9pPr>
                                        </a:lstStyle>
                                        <a:p>
                                          <a:pPr defTabSz="912813" eaLnBrk="1" fontAlgn="base" hangingPunct="1">
                                            <a:spcBef>
                                              <a:spcPct val="0"/>
                                            </a:spcBef>
                                            <a:spcAft>
                                              <a:spcPct val="0"/>
                                            </a:spcAft>
                                          </a:pPr>
                                          <a:r>
                                            <a:rPr lang="en-US" altLang="en-US" sz="1200" b="1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3.Immunophenotyping </a:t>
                                          </a:r>
                                          <a:r>
                                            <a:rPr lang="en-US" altLang="en-US" sz="1200" dirty="0">
                                              <a:solidFill>
                                                <a:sysClr val="windowText" lastClr="000000"/>
                                              </a:solidFill>
                                              <a:latin typeface="Times New Roman" panose="02020603050405020304" pitchFamily="18" charset="0"/>
                                              <a:cs typeface="Times New Roman" panose="02020603050405020304" pitchFamily="18" charset="0"/>
                                            </a:rPr>
                                            <a:t>:Surface staining for B memory, B,NK/NKT, T cells and subsets by flowcytometry (n=124)</a:t>
                                          </a:r>
                                        </a:p>
                                      </p:txBody>
                                    </p:sp>
                                  </p:grpSp>
                                  <p:cxnSp>
                                    <p:nvCxnSpPr>
                                      <p:cNvPr id="36" name="Straight Arrow Connector 35"/>
                                      <p:cNvCxnSpPr/>
                                      <p:nvPr/>
                                    </p:nvCxnSpPr>
                                    <p:spPr>
                                      <a:xfrm rot="5400000">
                                        <a:off x="3464435" y="1093905"/>
                                        <a:ext cx="304605" cy="1474"/>
                                      </a:xfrm>
                                      <a:prstGeom prst="straightConnector1">
                                        <a:avLst/>
                                      </a:prstGeom>
                                      <a:grpFill/>
                                      <a:ln w="12700">
                                        <a:tailEnd type="arrow"/>
                                      </a:ln>
                                    </p:spPr>
                                    <p:style>
                                      <a:lnRef idx="1">
                                        <a:schemeClr val="dk1"/>
                                      </a:lnRef>
                                      <a:fillRef idx="0">
                                        <a:schemeClr val="dk1"/>
                                      </a:fillRef>
                                      <a:effectRef idx="0">
                                        <a:schemeClr val="dk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sp>
                                    <p:nvSpPr>
                                      <p:cNvPr id="7214" name="TextBox 38"/>
                                      <p:cNvSpPr txBox="1">
                                        <a:spLocks noChangeArrowheads="1"/>
                                      </p:cNvSpPr>
                                      <p:nvPr/>
                                    </p:nvSpPr>
                                    <p:spPr bwMode="auto">
                                      <a:xfrm>
                                        <a:off x="2691377" y="1274978"/>
                                        <a:ext cx="2100145" cy="578297"/>
                                      </a:xfrm>
                                      <a:prstGeom prst="rect">
                                        <a:avLst/>
                                      </a:prstGeom>
                                      <a:grpFill/>
                                      <a:ln/>
                                    </p:spPr>
                                    <p:style>
                                      <a:lnRef idx="2">
                                        <a:schemeClr val="dk1"/>
                                      </a:lnRef>
                                      <a:fillRef idx="1">
                                        <a:schemeClr val="lt1"/>
                                      </a:fillRef>
                                      <a:effectRef idx="0">
                                        <a:schemeClr val="dk1"/>
                                      </a:effectRef>
                                      <a:fontRef idx="minor">
                                        <a:schemeClr val="dk1"/>
                                      </a:fontRef>
                                    </p:style>
                                    <p:txBody>
                                      <a:bodyPr wrap="square">
                                        <a:spAutoFit/>
                                      </a:bodyPr>
                                      <a:lstStyle>
                                        <a:lvl1pPr eaLnBrk="0" hangingPunct="0"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1pPr>
                                        <a:lvl2pPr marL="742950" indent="-285750" eaLnBrk="0" hangingPunct="0"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2pPr>
                                        <a:lvl3pPr marL="1143000" indent="-228600" eaLnBrk="0" hangingPunct="0"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3pPr>
                                        <a:lvl4pPr marL="1600200" indent="-228600" eaLnBrk="0" hangingPunct="0"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4pPr>
                                        <a:lvl5pPr marL="2057400" indent="-228600" eaLnBrk="0" hangingPunct="0"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5pPr>
                                        <a:lvl6pPr marL="2514600" indent="-228600" defTabSz="912813"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6pPr>
                                        <a:lvl7pPr marL="2971800" indent="-228600" defTabSz="912813"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7pPr>
                                        <a:lvl8pPr marL="3429000" indent="-228600" defTabSz="912813"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8pPr>
                                        <a:lvl9pPr marL="3886200" indent="-228600" defTabSz="912813" eaLnBrk="0" fontAlgn="base" hangingPunct="0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  <a:defRPr>
                                            <a:solidFill>
                                              <a:schemeClr val="tx1"/>
                                            </a:solidFill>
                                            <a:latin typeface="Arial" panose="020B0604020202020204" pitchFamily="34" charset="0"/>
                                            <a:cs typeface="Arial" panose="020B0604020202020204" pitchFamily="34" charset="0"/>
                                          </a:defRPr>
                                        </a:lvl9pPr>
                                      </a:lstStyle>
                                      <a:p>
                                        <a:pPr algn="ctr" defTabSz="912813" eaLnBrk="1" fontAlgn="base" hangingPunct="1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</a:pPr>
                                        <a:r>
                                          <a:rPr lang="en-IN" altLang="en-US" sz="1200" b="1" dirty="0">
                                            <a:solidFill>
                                              <a:sysClr val="windowText" lastClr="000000"/>
                                            </a:solidFill>
                                            <a:latin typeface="Times New Roman" panose="02020603050405020304" pitchFamily="18" charset="0"/>
                                            <a:cs typeface="Times New Roman" panose="02020603050405020304" pitchFamily="18" charset="0"/>
                                          </a:rPr>
                                          <a:t>R2 </a:t>
                                        </a:r>
                                      </a:p>
                                      <a:p>
                                        <a:pPr algn="ctr" defTabSz="912813" eaLnBrk="1" fontAlgn="base" hangingPunct="1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</a:pPr>
                                        <a:r>
                                          <a:rPr lang="en-IN" altLang="en-US" sz="1200" b="1" dirty="0">
                                            <a:solidFill>
                                              <a:sysClr val="windowText" lastClr="000000"/>
                                            </a:solidFill>
                                            <a:latin typeface="Times New Roman" panose="02020603050405020304" pitchFamily="18" charset="0"/>
                                            <a:cs typeface="Times New Roman" panose="02020603050405020304" pitchFamily="18" charset="0"/>
                                          </a:rPr>
                                          <a:t>(Recovered 8-9 months post recovery, </a:t>
                                        </a:r>
                                      </a:p>
                                      <a:p>
                                        <a:pPr algn="ctr" defTabSz="912813" eaLnBrk="1" fontAlgn="base" hangingPunct="1">
                                          <a:spcBef>
                                            <a:spcPct val="0"/>
                                          </a:spcBef>
                                          <a:spcAft>
                                            <a:spcPct val="0"/>
                                          </a:spcAft>
                                        </a:pPr>
                                        <a:r>
                                          <a:rPr lang="en-US" altLang="en-US" sz="1200" b="1" dirty="0">
                                            <a:solidFill>
                                              <a:sysClr val="windowText" lastClr="000000"/>
                                            </a:solidFill>
                                            <a:latin typeface="Times New Roman" panose="02020603050405020304" pitchFamily="18" charset="0"/>
                                            <a:cs typeface="Times New Roman" panose="02020603050405020304" pitchFamily="18" charset="0"/>
                                          </a:rPr>
                                          <a:t>n=40</a:t>
                                        </a:r>
                                        <a:r>
                                          <a:rPr lang="en-US" altLang="en-US" sz="1200" dirty="0">
                                            <a:solidFill>
                                              <a:sysClr val="windowText" lastClr="000000"/>
                                            </a:solidFill>
                                            <a:latin typeface="Times New Roman" panose="02020603050405020304" pitchFamily="18" charset="0"/>
                                            <a:cs typeface="Times New Roman" panose="02020603050405020304" pitchFamily="18" charset="0"/>
                                          </a:rPr>
                                          <a:t>)</a:t>
                                        </a:r>
                                      </a:p>
                                    </p:txBody>
                                  </p:sp>
                                </p:grpSp>
                                <p:cxnSp>
                                  <p:nvCxnSpPr>
                                    <p:cNvPr id="53" name="Straight Connector 52"/>
                                    <p:cNvCxnSpPr/>
                                    <p:nvPr/>
                                  </p:nvCxnSpPr>
                                  <p:spPr>
                                    <a:xfrm rot="5400000">
                                      <a:off x="3574591" y="1908392"/>
                                      <a:ext cx="160962" cy="1474"/>
                                    </a:xfrm>
                                    <a:prstGeom prst="line">
                                      <a:avLst/>
                                    </a:prstGeom>
                                    <a:grpFill/>
                                    <a:ln w="12700"/>
                                  </p:spPr>
                                  <p:style>
                                    <a:lnRef idx="1">
                                      <a:schemeClr val="dk1"/>
                                    </a:lnRef>
                                    <a:fillRef idx="0">
                                      <a:schemeClr val="dk1"/>
                                    </a:fillRef>
                                    <a:effectRef idx="0">
                                      <a:schemeClr val="dk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</p:grpSp>
                              <p:cxnSp>
                                <p:nvCxnSpPr>
                                  <p:cNvPr id="54" name="Straight Connector 53"/>
                                  <p:cNvCxnSpPr/>
                                  <p:nvPr/>
                                </p:nvCxnSpPr>
                                <p:spPr>
                                  <a:xfrm rot="5400000">
                                    <a:off x="7467041" y="1908392"/>
                                    <a:ext cx="160962" cy="1474"/>
                                  </a:xfrm>
                                  <a:prstGeom prst="line">
                                    <a:avLst/>
                                  </a:prstGeom>
                                  <a:grpFill/>
                                  <a:ln w="12700"/>
                                </p:spPr>
                                <p:style>
                                  <a:lnRef idx="1">
                                    <a:schemeClr val="dk1"/>
                                  </a:lnRef>
                                  <a:fillRef idx="0">
                                    <a:schemeClr val="dk1"/>
                                  </a:fillRef>
                                  <a:effectRef idx="0">
                                    <a:schemeClr val="dk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  <p:cxnSp>
                              <p:nvCxnSpPr>
                                <p:cNvPr id="60" name="Straight Connector 59"/>
                                <p:cNvCxnSpPr/>
                                <p:nvPr/>
                              </p:nvCxnSpPr>
                              <p:spPr>
                                <a:xfrm flipV="1">
                                  <a:off x="1601952" y="1983497"/>
                                  <a:ext cx="5941883" cy="6112"/>
                                </a:xfrm>
                                <a:prstGeom prst="line">
                                  <a:avLst/>
                                </a:prstGeom>
                                <a:grpFill/>
                                <a:ln w="12700"/>
                              </p:spPr>
                              <p:style>
                                <a:lnRef idx="1">
                                  <a:schemeClr val="dk1"/>
                                </a:lnRef>
                                <a:fillRef idx="0">
                                  <a:schemeClr val="dk1"/>
                                </a:fillRef>
                                <a:effectRef idx="0">
                                  <a:schemeClr val="dk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cxnSp>
                            <p:nvCxnSpPr>
                              <p:cNvPr id="62" name="Straight Connector 61"/>
                              <p:cNvCxnSpPr/>
                              <p:nvPr/>
                            </p:nvCxnSpPr>
                            <p:spPr>
                              <a:xfrm rot="5400000">
                                <a:off x="4325119" y="2095841"/>
                                <a:ext cx="213936" cy="1475"/>
                              </a:xfrm>
                              <a:prstGeom prst="line">
                                <a:avLst/>
                              </a:prstGeom>
                              <a:grpFill/>
                              <a:ln w="12700"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68" name="TextBox 67"/>
                            <p:cNvSpPr txBox="1"/>
                            <p:nvPr/>
                          </p:nvSpPr>
                          <p:spPr>
                            <a:xfrm>
                              <a:off x="984173" y="2514264"/>
                              <a:ext cx="1467041" cy="192766"/>
                            </a:xfrm>
                            <a:prstGeom prst="rect">
                              <a:avLst/>
                            </a:prstGeom>
                            <a:grpFill/>
                            <a:ln/>
                          </p:spPr>
                          <p:style>
                            <a:lnRef idx="2">
                              <a:schemeClr val="dk1"/>
                            </a:lnRef>
                            <a:fillRef idx="1">
                              <a:schemeClr val="lt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dk1"/>
                            </a:fontRef>
                          </p:style>
                          <p:txBody>
                            <a:bodyPr>
                              <a:spAutoFit/>
                            </a:bodyPr>
                            <a:lstStyle/>
                            <a:p>
                              <a:pPr marL="0" lvl="1" indent="1588" algn="ctr" defTabSz="912813" fontAlgn="base">
                                <a:spcBef>
                                  <a:spcPct val="0"/>
                                </a:spcBef>
                                <a:spcAft>
                                  <a:spcPct val="0"/>
                                </a:spcAft>
                                <a:defRPr/>
                              </a:pPr>
                              <a:r>
                                <a:rPr lang="en-US" sz="1200" b="1" dirty="0">
                                  <a:solidFill>
                                    <a:prstClr val="black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Plasma</a:t>
                              </a:r>
                            </a:p>
                          </p:txBody>
                        </p:sp>
                      </p:grpSp>
                    </p:grpSp>
                    <p:cxnSp>
                      <p:nvCxnSpPr>
                        <p:cNvPr id="78" name="Straight Arrow Connector 77"/>
                        <p:cNvCxnSpPr/>
                        <p:nvPr/>
                      </p:nvCxnSpPr>
                      <p:spPr>
                        <a:xfrm>
                          <a:off x="3083737" y="4483498"/>
                          <a:ext cx="302255" cy="2037"/>
                        </a:xfrm>
                        <a:prstGeom prst="straightConnector1">
                          <a:avLst/>
                        </a:prstGeom>
                        <a:grpFill/>
                        <a:ln w="12700">
                          <a:tailEnd type="arrow"/>
                        </a:ln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7195" name="TextBox 54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5020100" y="1262602"/>
                        <a:ext cx="1678391" cy="578297"/>
                      </a:xfrm>
                      <a:prstGeom prst="rect">
                        <a:avLst/>
                      </a:prstGeom>
                      <a:grpFill/>
                      <a:ln/>
                    </p:spPr>
                    <p:style>
                      <a:lnRef idx="2">
                        <a:schemeClr val="dk1"/>
                      </a:lnRef>
                      <a:fillRef idx="1">
                        <a:schemeClr val="lt1"/>
                      </a:fillRef>
                      <a:effectRef idx="0">
                        <a:schemeClr val="dk1"/>
                      </a:effectRef>
                      <a:fontRef idx="minor">
                        <a:schemeClr val="dk1"/>
                      </a:fontRef>
                    </p:style>
                    <p:txBody>
                      <a:bodyPr wrap="square">
                        <a:spAutoFit/>
                      </a:bodyPr>
                      <a:lstStyle>
                        <a:lvl1pPr eaLnBrk="0" hangingPunct="0"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  <a:lvl2pPr marL="742950" indent="-285750" eaLnBrk="0" hangingPunct="0"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2pPr>
                        <a:lvl3pPr marL="1143000" indent="-228600" eaLnBrk="0" hangingPunct="0"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3pPr>
                        <a:lvl4pPr marL="1600200" indent="-228600" eaLnBrk="0" hangingPunct="0"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4pPr>
                        <a:lvl5pPr marL="2057400" indent="-228600" eaLnBrk="0" hangingPunct="0"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5pPr>
                        <a:lvl6pPr marL="2514600" indent="-228600" defTabSz="912813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6pPr>
                        <a:lvl7pPr marL="2971800" indent="-228600" defTabSz="912813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7pPr>
                        <a:lvl8pPr marL="3429000" indent="-228600" defTabSz="912813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8pPr>
                        <a:lvl9pPr marL="3886200" indent="-228600" defTabSz="912813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9pPr>
                      </a:lstStyle>
                      <a:p>
                        <a:pPr algn="ctr" defTabSz="912813" eaLnBrk="1" fontAlgn="base" hangingPunct="1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lang="en-IN" altLang="en-US" sz="1200" b="1" dirty="0">
                            <a:solidFill>
                              <a:sysClr val="windowText" lastClr="00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3</a:t>
                        </a:r>
                      </a:p>
                      <a:p>
                        <a:pPr algn="ctr" defTabSz="912813" eaLnBrk="1" fontAlgn="base" hangingPunct="1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lang="en-IN" altLang="en-US" sz="1200" b="1" dirty="0">
                            <a:solidFill>
                              <a:sysClr val="windowText" lastClr="00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(Recovered  1 year post recovery, </a:t>
                        </a:r>
                      </a:p>
                      <a:p>
                        <a:pPr algn="ctr" defTabSz="912813" eaLnBrk="1" fontAlgn="base" hangingPunct="1">
                          <a:spcBef>
                            <a:spcPct val="0"/>
                          </a:spcBef>
                          <a:spcAft>
                            <a:spcPct val="0"/>
                          </a:spcAft>
                        </a:pPr>
                        <a:r>
                          <a:rPr lang="en-IN" altLang="en-US" sz="1200" b="1" dirty="0">
                            <a:solidFill>
                              <a:sysClr val="windowText" lastClr="00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</a:t>
                        </a:r>
                        <a:r>
                          <a:rPr lang="en-US" altLang="en-US" sz="1200" b="1" dirty="0">
                            <a:solidFill>
                              <a:sysClr val="windowText" lastClr="00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=27</a:t>
                        </a:r>
                        <a:r>
                          <a:rPr lang="en-US" altLang="en-US" sz="1200" dirty="0">
                            <a:solidFill>
                              <a:sysClr val="windowText" lastClr="00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)*</a:t>
                        </a:r>
                      </a:p>
                    </p:txBody>
                  </p:sp>
                  <p:cxnSp>
                    <p:nvCxnSpPr>
                      <p:cNvPr id="56" name="Straight Arrow Connector 55"/>
                      <p:cNvCxnSpPr/>
                      <p:nvPr/>
                    </p:nvCxnSpPr>
                    <p:spPr>
                      <a:xfrm rot="5400000">
                        <a:off x="5472291" y="1093899"/>
                        <a:ext cx="304605" cy="1488"/>
                      </a:xfrm>
                      <a:prstGeom prst="straightConnector1">
                        <a:avLst/>
                      </a:prstGeom>
                      <a:grpFill/>
                      <a:ln w="12700">
                        <a:tailEnd type="arrow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8" name="Straight Connector 57"/>
                      <p:cNvCxnSpPr/>
                      <p:nvPr/>
                    </p:nvCxnSpPr>
                    <p:spPr>
                      <a:xfrm rot="5400000">
                        <a:off x="5450425" y="1908386"/>
                        <a:ext cx="160962" cy="1487"/>
                      </a:xfrm>
                      <a:prstGeom prst="line">
                        <a:avLst/>
                      </a:prstGeom>
                      <a:grpFill/>
                      <a:ln w="1270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69" name="Straight Connector 68"/>
                    <p:cNvCxnSpPr/>
                    <p:nvPr/>
                  </p:nvCxnSpPr>
                  <p:spPr bwMode="auto">
                    <a:xfrm>
                      <a:off x="3075202" y="3493053"/>
                      <a:ext cx="20640" cy="2597164"/>
                    </a:xfrm>
                    <a:prstGeom prst="line">
                      <a:avLst/>
                    </a:prstGeom>
                    <a:grpFill/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0" name="Straight Arrow Connector 99"/>
                    <p:cNvCxnSpPr/>
                    <p:nvPr/>
                  </p:nvCxnSpPr>
                  <p:spPr bwMode="auto">
                    <a:xfrm rot="16200000" flipH="1">
                      <a:off x="1562295" y="3848799"/>
                      <a:ext cx="228434" cy="0"/>
                    </a:xfrm>
                    <a:prstGeom prst="straightConnector1">
                      <a:avLst/>
                    </a:prstGeom>
                    <a:grpFill/>
                    <a:ln w="12700">
                      <a:tailEnd type="arrow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02" name="Rectangle 101"/>
                    <p:cNvSpPr/>
                    <p:nvPr/>
                  </p:nvSpPr>
                  <p:spPr>
                    <a:xfrm>
                      <a:off x="381016" y="3963017"/>
                      <a:ext cx="2246477" cy="807521"/>
                    </a:xfrm>
                    <a:prstGeom prst="rect">
                      <a:avLst/>
                    </a:prstGeom>
                    <a:grpFill/>
                    <a:ln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anchor="ctr"/>
                    <a:lstStyle/>
                    <a:p>
                      <a:pPr defTabSz="912813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/>
                      </a:pPr>
                      <a:r>
                        <a:rPr lang="en-GB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ELISAs:</a:t>
                      </a:r>
                      <a:r>
                        <a:rPr lang="en-GB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ection of anti-SARS CoV2 IgG by KAVACH ELISA kit (n=163)</a:t>
                      </a:r>
                      <a:endParaRPr 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73" name="Straight Arrow Connector 72"/>
                    <p:cNvCxnSpPr/>
                    <p:nvPr/>
                  </p:nvCxnSpPr>
                  <p:spPr bwMode="auto">
                    <a:xfrm flipH="1">
                      <a:off x="7884094" y="2848491"/>
                      <a:ext cx="0" cy="414673"/>
                    </a:xfrm>
                    <a:prstGeom prst="straightConnector1">
                      <a:avLst/>
                    </a:prstGeom>
                    <a:grpFill/>
                    <a:ln w="12700">
                      <a:tailEnd type="arrow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7" name="Straight Arrow Connector 96"/>
                    <p:cNvCxnSpPr/>
                    <p:nvPr/>
                  </p:nvCxnSpPr>
                  <p:spPr bwMode="auto">
                    <a:xfrm flipV="1">
                      <a:off x="3095841" y="5211401"/>
                      <a:ext cx="374678" cy="10184"/>
                    </a:xfrm>
                    <a:prstGeom prst="straightConnector1">
                      <a:avLst/>
                    </a:prstGeom>
                    <a:grpFill/>
                    <a:ln w="12700">
                      <a:tailEnd type="arrow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9" name="Straight Connector 58"/>
                  <p:cNvCxnSpPr/>
                  <p:nvPr/>
                </p:nvCxnSpPr>
                <p:spPr bwMode="auto">
                  <a:xfrm>
                    <a:off x="152400" y="3504693"/>
                    <a:ext cx="685850" cy="2910"/>
                  </a:xfrm>
                  <a:prstGeom prst="line">
                    <a:avLst/>
                  </a:prstGeom>
                  <a:grpFill/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Straight Connector 60"/>
                  <p:cNvCxnSpPr/>
                  <p:nvPr/>
                </p:nvCxnSpPr>
                <p:spPr bwMode="auto">
                  <a:xfrm flipH="1">
                    <a:off x="152400" y="3504693"/>
                    <a:ext cx="1587" cy="1855117"/>
                  </a:xfrm>
                  <a:prstGeom prst="line">
                    <a:avLst/>
                  </a:prstGeom>
                  <a:grpFill/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Straight Arrow Connector 74"/>
                  <p:cNvCxnSpPr/>
                  <p:nvPr/>
                </p:nvCxnSpPr>
                <p:spPr bwMode="auto">
                  <a:xfrm>
                    <a:off x="152400" y="5359810"/>
                    <a:ext cx="228617" cy="1455"/>
                  </a:xfrm>
                  <a:prstGeom prst="straightConnector1">
                    <a:avLst/>
                  </a:prstGeom>
                  <a:grpFill/>
                  <a:ln w="12700"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178" name="TextBox 63"/>
                <p:cNvSpPr txBox="1">
                  <a:spLocks noChangeArrowheads="1"/>
                </p:cNvSpPr>
                <p:nvPr/>
              </p:nvSpPr>
              <p:spPr bwMode="auto">
                <a:xfrm>
                  <a:off x="393909" y="5469633"/>
                  <a:ext cx="2247188" cy="901038"/>
                </a:xfrm>
                <a:prstGeom prst="rect">
                  <a:avLst/>
                </a:prstGeom>
                <a:grpFill/>
                <a:ln>
                  <a:headEnd/>
                  <a:tailEnd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.Neutralization assay:</a:t>
                  </a:r>
                  <a:r>
                    <a:rPr lang="en-GB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tection of anti-SARS CoV2 </a:t>
                  </a:r>
                  <a:r>
                    <a:rPr lang="en-US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utralizing antibodies by VNT assay: </a:t>
                  </a:r>
                  <a:r>
                    <a:rPr lang="en-US" altLang="en-US" sz="1200" dirty="0" err="1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eneScript</a:t>
                  </a:r>
                  <a:r>
                    <a:rPr lang="en-US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it (n=106)</a:t>
                  </a:r>
                  <a:endParaRPr lang="en-US" altLang="en-US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79" name="TextBox 49"/>
                <p:cNvSpPr txBox="1">
                  <a:spLocks noChangeArrowheads="1"/>
                </p:cNvSpPr>
                <p:nvPr/>
              </p:nvSpPr>
              <p:spPr bwMode="auto">
                <a:xfrm>
                  <a:off x="3462385" y="5534896"/>
                  <a:ext cx="5695359" cy="500576"/>
                </a:xfrm>
                <a:prstGeom prst="rect">
                  <a:avLst/>
                </a:prstGeom>
                <a:grpFill/>
                <a:ln>
                  <a:headEnd/>
                  <a:tailEnd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.Functional assay:</a:t>
                  </a:r>
                  <a:r>
                    <a:rPr lang="en-US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Intracellular cytokine staining for the expression of IFN-</a:t>
                  </a:r>
                  <a:r>
                    <a:rPr lang="el-GR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γ</a:t>
                  </a:r>
                  <a:r>
                    <a:rPr lang="en-US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&amp; CD107a by flowcytometry (n=58)</a:t>
                  </a:r>
                </a:p>
              </p:txBody>
            </p:sp>
            <p:cxnSp>
              <p:nvCxnSpPr>
                <p:cNvPr id="67" name="Straight Arrow Connector 66"/>
                <p:cNvCxnSpPr/>
                <p:nvPr/>
              </p:nvCxnSpPr>
              <p:spPr bwMode="auto">
                <a:xfrm>
                  <a:off x="157163" y="4895965"/>
                  <a:ext cx="227030" cy="9524"/>
                </a:xfrm>
                <a:prstGeom prst="straightConnector1">
                  <a:avLst/>
                </a:prstGeom>
                <a:grpFill/>
                <a:ln w="9525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Arrow Connector 73"/>
                <p:cNvCxnSpPr/>
                <p:nvPr/>
              </p:nvCxnSpPr>
              <p:spPr bwMode="auto">
                <a:xfrm flipV="1">
                  <a:off x="3086317" y="6365801"/>
                  <a:ext cx="374678" cy="0"/>
                </a:xfrm>
                <a:prstGeom prst="straightConnector1">
                  <a:avLst/>
                </a:prstGeom>
                <a:grpFill/>
                <a:ln w="635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182" name="TextBox 37"/>
                <p:cNvSpPr txBox="1">
                  <a:spLocks noChangeArrowheads="1"/>
                </p:cNvSpPr>
                <p:nvPr/>
              </p:nvSpPr>
              <p:spPr bwMode="auto">
                <a:xfrm>
                  <a:off x="3447438" y="6619309"/>
                  <a:ext cx="4443804" cy="300346"/>
                </a:xfrm>
                <a:prstGeom prst="rect">
                  <a:avLst/>
                </a:prstGeom>
                <a:grpFill/>
                <a:ln>
                  <a:headEnd/>
                  <a:tailEnd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.SARS CoV-2 specific 27 plex cytokine assay </a:t>
                  </a:r>
                  <a:r>
                    <a:rPr lang="en-US" alt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n=52)</a:t>
                  </a:r>
                </a:p>
              </p:txBody>
            </p:sp>
          </p:grpSp>
          <p:cxnSp>
            <p:nvCxnSpPr>
              <p:cNvPr id="71" name="Straight Arrow Connector 70"/>
              <p:cNvCxnSpPr/>
              <p:nvPr/>
            </p:nvCxnSpPr>
            <p:spPr bwMode="auto">
              <a:xfrm flipH="1">
                <a:off x="1608245" y="3237241"/>
                <a:ext cx="0" cy="453967"/>
              </a:xfrm>
              <a:prstGeom prst="straightConnector1">
                <a:avLst/>
              </a:prstGeom>
              <a:grpFill/>
              <a:ln w="12700"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172" name="TextBox 37"/>
            <p:cNvSpPr txBox="1">
              <a:spLocks noChangeArrowheads="1"/>
            </p:cNvSpPr>
            <p:nvPr/>
          </p:nvSpPr>
          <p:spPr bwMode="auto">
            <a:xfrm>
              <a:off x="3353033" y="4626279"/>
              <a:ext cx="5719769" cy="500576"/>
            </a:xfrm>
            <a:prstGeom prst="rect">
              <a:avLst/>
            </a:prstGeom>
            <a:grpFill/>
            <a:ln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defTabSz="912813"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.SARS-CoV-2 specific immunophenotyping  : </a:t>
              </a:r>
              <a:r>
                <a:rPr lang="en-US" altLang="en-US" sz="12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face staining for B memory, B,T cells and subsets by flowcytometry (n=67)</a:t>
              </a:r>
            </a:p>
          </p:txBody>
        </p:sp>
        <p:cxnSp>
          <p:nvCxnSpPr>
            <p:cNvPr id="72" name="Straight Arrow Connector 71"/>
            <p:cNvCxnSpPr>
              <a:endCxn id="7222" idx="1"/>
            </p:cNvCxnSpPr>
            <p:nvPr/>
          </p:nvCxnSpPr>
          <p:spPr bwMode="auto">
            <a:xfrm flipV="1">
              <a:off x="2956976" y="4202752"/>
              <a:ext cx="406616" cy="41966"/>
            </a:xfrm>
            <a:prstGeom prst="straightConnector1">
              <a:avLst/>
            </a:prstGeom>
            <a:grpFill/>
            <a:ln w="127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Straight Arrow Connector 76"/>
            <p:cNvCxnSpPr/>
            <p:nvPr/>
          </p:nvCxnSpPr>
          <p:spPr bwMode="auto">
            <a:xfrm flipV="1">
              <a:off x="2976027" y="4919320"/>
              <a:ext cx="374678" cy="11111"/>
            </a:xfrm>
            <a:prstGeom prst="straightConnector1">
              <a:avLst/>
            </a:prstGeom>
            <a:grpFill/>
            <a:ln w="127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05BBF907-93EB-E2E5-559B-393A9F0170B8}"/>
              </a:ext>
            </a:extLst>
          </p:cNvPr>
          <p:cNvSpPr txBox="1"/>
          <p:nvPr/>
        </p:nvSpPr>
        <p:spPr>
          <a:xfrm>
            <a:off x="1086397" y="109966"/>
            <a:ext cx="100192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schematic representation of study outline indicating the number of individuals assessed in each assay 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8544B7-857F-2982-6C8C-3076B788A25B}"/>
              </a:ext>
            </a:extLst>
          </p:cNvPr>
          <p:cNvSpPr txBox="1"/>
          <p:nvPr/>
        </p:nvSpPr>
        <p:spPr>
          <a:xfrm>
            <a:off x="825338" y="6480587"/>
            <a:ext cx="96589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5 recovered individuals reported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st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ose of vaccination and hence were removed from further analysis. 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4661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4CE012C-7771-9CCF-B2F8-FDC3B9648CBD}"/>
              </a:ext>
            </a:extLst>
          </p:cNvPr>
          <p:cNvGrpSpPr/>
          <p:nvPr/>
        </p:nvGrpSpPr>
        <p:grpSpPr>
          <a:xfrm>
            <a:off x="170984" y="582624"/>
            <a:ext cx="9976376" cy="5692751"/>
            <a:chOff x="657944" y="192194"/>
            <a:chExt cx="11041015" cy="634257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022B3EA-6C82-8CD5-5942-43E035A28A44}"/>
                </a:ext>
              </a:extLst>
            </p:cNvPr>
            <p:cNvSpPr txBox="1"/>
            <p:nvPr/>
          </p:nvSpPr>
          <p:spPr>
            <a:xfrm>
              <a:off x="657944" y="3302520"/>
              <a:ext cx="3717336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  <a:r>
                <a:rPr lang="en-IN" sz="1200" kern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Neutralization antibody activities against SARS-CoV-2 infection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 1-2 months post recovery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F034F50-8AA5-9672-E973-DC6F9300C3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4487" y="707952"/>
              <a:ext cx="3560794" cy="2440852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05E34BE-3580-556F-E49C-11E411E3DCBB}"/>
                </a:ext>
              </a:extLst>
            </p:cNvPr>
            <p:cNvSpPr txBox="1"/>
            <p:nvPr/>
          </p:nvSpPr>
          <p:spPr>
            <a:xfrm>
              <a:off x="657944" y="212913"/>
              <a:ext cx="3560794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T cells response by ELISPOT  in recovered individuals at  1-2 months post recovery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415F689-FEDA-D37A-F0C8-78EDEA1260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grayscl/>
            </a:blip>
            <a:srcRect t="1472" r="2133" b="3580"/>
            <a:stretch/>
          </p:blipFill>
          <p:spPr>
            <a:xfrm>
              <a:off x="850400" y="3836831"/>
              <a:ext cx="3561955" cy="26979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0171B31-E1E2-A3C0-E766-EBEA6CC94D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grayscl/>
            </a:blip>
            <a:srcRect r="1311"/>
            <a:stretch/>
          </p:blipFill>
          <p:spPr>
            <a:xfrm>
              <a:off x="4412355" y="715786"/>
              <a:ext cx="3560793" cy="24330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8564632-D9D2-3EE0-EEE4-8F69A3CD2A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grayscl/>
            </a:blip>
            <a:srcRect r="3046" b="6402"/>
            <a:stretch/>
          </p:blipFill>
          <p:spPr>
            <a:xfrm>
              <a:off x="4470105" y="3827205"/>
              <a:ext cx="3585552" cy="26979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A94DBE1-815F-33CF-E7DC-ABCEC8F4AB53}"/>
                </a:ext>
              </a:extLst>
            </p:cNvPr>
            <p:cNvSpPr txBox="1"/>
            <p:nvPr/>
          </p:nvSpPr>
          <p:spPr>
            <a:xfrm>
              <a:off x="4470105" y="192194"/>
              <a:ext cx="3404366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T cells response by ELISPOT  in recovered individuals at  8-9 months post recovery</a:t>
              </a:r>
              <a:endParaRPr lang="en-IN" sz="12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4113861-3FC2-B8B5-639C-D2FB880051F3}"/>
                </a:ext>
              </a:extLst>
            </p:cNvPr>
            <p:cNvSpPr txBox="1"/>
            <p:nvPr/>
          </p:nvSpPr>
          <p:spPr>
            <a:xfrm>
              <a:off x="4453000" y="3272657"/>
              <a:ext cx="3717336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</a:t>
              </a:r>
              <a:r>
                <a:rPr lang="en-IN" sz="1200" kern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Neutralization antibody activities against SARS-CoV-2 infection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 8-9 months post recovery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26AB0EC-A8F5-2B4B-D5C0-36FCCBDC53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grayscl/>
            </a:blip>
            <a:srcRect r="3238"/>
            <a:stretch/>
          </p:blipFill>
          <p:spPr>
            <a:xfrm>
              <a:off x="8010222" y="694999"/>
              <a:ext cx="3560793" cy="24408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3D122B0-C9CA-77B8-70A0-EEA45DCF438A}"/>
                </a:ext>
              </a:extLst>
            </p:cNvPr>
            <p:cNvSpPr txBox="1"/>
            <p:nvPr/>
          </p:nvSpPr>
          <p:spPr>
            <a:xfrm>
              <a:off x="8125838" y="225610"/>
              <a:ext cx="3338515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T cells response by ELISPOT  in recovered individuals 1 year post recovery</a:t>
              </a:r>
              <a:endParaRPr lang="en-IN" sz="12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62FAA34-5D93-32AD-D311-650FAC8D31E8}"/>
                </a:ext>
              </a:extLst>
            </p:cNvPr>
            <p:cNvSpPr txBox="1"/>
            <p:nvPr/>
          </p:nvSpPr>
          <p:spPr>
            <a:xfrm>
              <a:off x="8055657" y="3285359"/>
              <a:ext cx="3585553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.</a:t>
              </a:r>
              <a:r>
                <a:rPr lang="en-IN" sz="1200" kern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Neutralization antibody activities against SARS-CoV-2 infection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 1 year post recovery</a:t>
              </a:r>
              <a:endParaRPr lang="en-IN" sz="1200" dirty="0"/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4BACFE6-E225-3BDB-6DA5-BDC6300CED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grayscl/>
            </a:blip>
            <a:srcRect r="6819" b="3492"/>
            <a:stretch/>
          </p:blipFill>
          <p:spPr>
            <a:xfrm>
              <a:off x="8113407" y="3827204"/>
              <a:ext cx="3585552" cy="27075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E876A32C-F22F-1457-7530-15097F8719C3}"/>
              </a:ext>
            </a:extLst>
          </p:cNvPr>
          <p:cNvSpPr txBox="1"/>
          <p:nvPr/>
        </p:nvSpPr>
        <p:spPr>
          <a:xfrm>
            <a:off x="10211106" y="671691"/>
            <a:ext cx="1809910" cy="58999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 cells response by ELISPOT and neutralization antibody activities w.r.t asymptomatic/symptomatic recovery and IgG status in recovered individuals. A-C:T cells response by ELISPOT  in recovered individuals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Magnitude of the SARS-CoV-2-S1 specific IFN-γ producing T cell response represented  in terms of percentage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-F: neutralization antibody activities against SARS-CoV-2 infection,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Y-axis represents % of signal inhibition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1:1-2 months post recovery A: Asymptomatic, S: Mild symptomatic, R:  responders IgG+: Anti-SARS-CoV-2 positive, IgG-: Anti-SARS-CoV-2 negative.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9" name="Rectangle 3">
            <a:extLst>
              <a:ext uri="{FF2B5EF4-FFF2-40B4-BE49-F238E27FC236}">
                <a16:creationId xmlns:a16="http://schemas.microsoft.com/office/drawing/2014/main" id="{BA192C52-09F4-D4FA-45DA-DAAEF185CA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838" y="113419"/>
            <a:ext cx="1164273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T cells response by ELISPOT and neutralization antibody activities w.r.t asymptomatic/symptomatic recovery and IgG status in recovered individuals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0847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77</Words>
  <Application>Microsoft Office PowerPoint</Application>
  <PresentationFormat>Widescreen</PresentationFormat>
  <Paragraphs>39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s 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</dc:title>
  <dc:creator>Diptee Trimbake</dc:creator>
  <cp:lastModifiedBy>anuradha mishra</cp:lastModifiedBy>
  <cp:revision>2</cp:revision>
  <dcterms:created xsi:type="dcterms:W3CDTF">2024-12-20T07:09:55Z</dcterms:created>
  <dcterms:modified xsi:type="dcterms:W3CDTF">2024-12-24T08:21:46Z</dcterms:modified>
</cp:coreProperties>
</file>